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144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B00"/>
    <a:srgbClr val="0000C1"/>
    <a:srgbClr val="0200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394" y="84"/>
      </p:cViewPr>
      <p:guideLst>
        <p:guide orient="horz" pos="285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717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808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5720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835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774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6147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526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537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2405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295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2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79144"/>
            <a:ext cx="78867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395710"/>
            <a:ext cx="78867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8341240"/>
            <a:ext cx="20574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4C645-7888-42DE-AC94-572639A42BB8}" type="datetimeFigureOut">
              <a:rPr lang="en-GB" smtClean="0"/>
              <a:t>05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8341240"/>
            <a:ext cx="30861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8341240"/>
            <a:ext cx="20574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B3A39-5431-4D51-8125-DE91FC6F20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931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26" Type="http://schemas.openxmlformats.org/officeDocument/2006/relationships/image" Target="../media/image25.emf"/><Relationship Id="rId39" Type="http://schemas.microsoft.com/office/2007/relationships/hdphoto" Target="../media/hdphoto1.wdp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34" Type="http://schemas.openxmlformats.org/officeDocument/2006/relationships/image" Target="../media/image33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33" Type="http://schemas.openxmlformats.org/officeDocument/2006/relationships/image" Target="../media/image32.emf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emf"/><Relationship Id="rId20" Type="http://schemas.openxmlformats.org/officeDocument/2006/relationships/image" Target="../media/image19.png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emf"/><Relationship Id="rId32" Type="http://schemas.openxmlformats.org/officeDocument/2006/relationships/image" Target="../media/image31.emf"/><Relationship Id="rId37" Type="http://schemas.openxmlformats.org/officeDocument/2006/relationships/image" Target="../media/image36.emf"/><Relationship Id="rId40" Type="http://schemas.openxmlformats.org/officeDocument/2006/relationships/image" Target="../media/image38.png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31" Type="http://schemas.openxmlformats.org/officeDocument/2006/relationships/image" Target="../media/image30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Relationship Id="rId27" Type="http://schemas.openxmlformats.org/officeDocument/2006/relationships/image" Target="../media/image26.emf"/><Relationship Id="rId30" Type="http://schemas.openxmlformats.org/officeDocument/2006/relationships/image" Target="../media/image29.emf"/><Relationship Id="rId35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744AE32-6481-49D0-B4CE-FA576ECD038F}"/>
              </a:ext>
            </a:extLst>
          </p:cNvPr>
          <p:cNvGrpSpPr/>
          <p:nvPr/>
        </p:nvGrpSpPr>
        <p:grpSpPr>
          <a:xfrm>
            <a:off x="2801598" y="117475"/>
            <a:ext cx="4980311" cy="8703917"/>
            <a:chOff x="1715748" y="117476"/>
            <a:chExt cx="4980311" cy="8703917"/>
          </a:xfrm>
        </p:grpSpPr>
        <p:pic>
          <p:nvPicPr>
            <p:cNvPr id="98" name="Picture 6">
              <a:extLst>
                <a:ext uri="{FF2B5EF4-FFF2-40B4-BE49-F238E27FC236}">
                  <a16:creationId xmlns:a16="http://schemas.microsoft.com/office/drawing/2014/main" id="{06245CB0-468B-4E85-9D0B-DB305F9F22C2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5796059" y="2260665"/>
              <a:ext cx="900000" cy="9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71C236D-CC4F-4CEF-97A7-59880A83C63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96059" y="7921393"/>
              <a:ext cx="900000" cy="9000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F4451B8-EFAC-4630-B4BB-BFDC507AF92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 rot="16200000">
              <a:off x="5796059" y="5073972"/>
              <a:ext cx="900000" cy="900000"/>
            </a:xfrm>
            <a:prstGeom prst="rect">
              <a:avLst/>
            </a:prstGeom>
          </p:spPr>
        </p:pic>
        <p:pic>
          <p:nvPicPr>
            <p:cNvPr id="1038" name="Picture 1037">
              <a:extLst>
                <a:ext uri="{FF2B5EF4-FFF2-40B4-BE49-F238E27FC236}">
                  <a16:creationId xmlns:a16="http://schemas.microsoft.com/office/drawing/2014/main" id="{F0A6D95E-9888-4A93-A16C-3B8F3370F04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96059" y="4132584"/>
              <a:ext cx="900000" cy="900000"/>
            </a:xfrm>
            <a:prstGeom prst="rect">
              <a:avLst/>
            </a:prstGeom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A0BE79D8-45D1-49B5-BAB4-31481E8C728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96059" y="1322897"/>
              <a:ext cx="900000" cy="9000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B0C7021C-F511-410C-A73B-38D4E0BA3EA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96059" y="398883"/>
              <a:ext cx="900000" cy="90000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273FABA-1167-4715-ACB1-F2FE9E6B449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96059" y="3198434"/>
              <a:ext cx="900000" cy="9000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2DB9E62-602F-4910-ADFE-F0AA006DF931}"/>
                </a:ext>
              </a:extLst>
            </p:cNvPr>
            <p:cNvSpPr txBox="1"/>
            <p:nvPr/>
          </p:nvSpPr>
          <p:spPr>
            <a:xfrm rot="16200000">
              <a:off x="1604821" y="667699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Rin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269D5AE-12F3-4981-B5FB-6AB0A406180D}"/>
                </a:ext>
              </a:extLst>
            </p:cNvPr>
            <p:cNvSpPr txBox="1"/>
            <p:nvPr/>
          </p:nvSpPr>
          <p:spPr>
            <a:xfrm rot="16200000">
              <a:off x="1360010" y="1611840"/>
              <a:ext cx="9884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Trophozoit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BA5821A-DCE2-47AA-B3C1-5F3EF3C6072A}"/>
                </a:ext>
              </a:extLst>
            </p:cNvPr>
            <p:cNvSpPr txBox="1"/>
            <p:nvPr/>
          </p:nvSpPr>
          <p:spPr>
            <a:xfrm rot="16200000">
              <a:off x="1467764" y="2550310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Schizont</a:t>
              </a: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B634A107-4B62-4446-B5E9-4EAE7166ED3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>
              <a:lum bright="-8000" contrast="-8000"/>
            </a:blip>
            <a:stretch>
              <a:fillRect/>
            </a:stretch>
          </p:blipFill>
          <p:spPr>
            <a:xfrm>
              <a:off x="2011398" y="6965541"/>
              <a:ext cx="900000" cy="900000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0025B613-6F4B-43A4-9D81-12F7BCA6BD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964661" y="6965541"/>
              <a:ext cx="900000" cy="900000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36795E70-84B8-4E29-9981-FC9E70004E5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23321" y="6965541"/>
              <a:ext cx="900000" cy="900000"/>
            </a:xfrm>
            <a:prstGeom prst="rect">
              <a:avLst/>
            </a:prstGeom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00A6B868-98CF-4060-A8E1-51862D1F0C8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862570" y="6965541"/>
              <a:ext cx="900000" cy="900000"/>
            </a:xfrm>
            <a:prstGeom prst="rect">
              <a:avLst/>
            </a:prstGeom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06DBBC01-3973-4F98-9E16-434A67CF8CB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796059" y="6962594"/>
              <a:ext cx="900000" cy="900000"/>
            </a:xfrm>
            <a:prstGeom prst="rect">
              <a:avLst/>
            </a:prstGeom>
          </p:spPr>
        </p:pic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927C83DC-0766-468E-B035-198CA51D6E1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964661" y="6027447"/>
              <a:ext cx="900000" cy="900000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F72C64D3-B96A-41B7-92C0-B442E27B102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>
              <a:lum bright="-12000"/>
            </a:blip>
            <a:stretch>
              <a:fillRect/>
            </a:stretch>
          </p:blipFill>
          <p:spPr>
            <a:xfrm>
              <a:off x="2011398" y="6027447"/>
              <a:ext cx="900000" cy="900000"/>
            </a:xfrm>
            <a:prstGeom prst="rect">
              <a:avLst/>
            </a:prstGeom>
          </p:spPr>
        </p:pic>
        <p:pic>
          <p:nvPicPr>
            <p:cNvPr id="60" name="Picture 59">
              <a:extLst>
                <a:ext uri="{FF2B5EF4-FFF2-40B4-BE49-F238E27FC236}">
                  <a16:creationId xmlns:a16="http://schemas.microsoft.com/office/drawing/2014/main" id="{F27B8B7A-10F0-4BED-9260-734BB2DDF23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923321" y="6027447"/>
              <a:ext cx="900000" cy="900000"/>
            </a:xfrm>
            <a:prstGeom prst="rect">
              <a:avLst/>
            </a:prstGeom>
          </p:spPr>
        </p:pic>
        <p:pic>
          <p:nvPicPr>
            <p:cNvPr id="61" name="Picture 60">
              <a:extLst>
                <a:ext uri="{FF2B5EF4-FFF2-40B4-BE49-F238E27FC236}">
                  <a16:creationId xmlns:a16="http://schemas.microsoft.com/office/drawing/2014/main" id="{0C20BCE8-8FA7-40E3-9837-CFD93826C85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96059" y="6021554"/>
              <a:ext cx="900000" cy="900000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27A28696-C833-429B-86A0-309E0B69912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862570" y="6027447"/>
              <a:ext cx="900000" cy="900000"/>
            </a:xfrm>
            <a:prstGeom prst="rect">
              <a:avLst/>
            </a:prstGeom>
          </p:spPr>
        </p:pic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E1390B78-52F3-4A79-8CB0-635B5D69EC0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011398" y="7903636"/>
              <a:ext cx="900000" cy="900000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D3EC5A33-D89D-4117-874F-15DD6389E5F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862570" y="3213165"/>
              <a:ext cx="900000" cy="900000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3FFCAE61-9EB8-4030-9203-E96F3395C1F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3923321" y="3213165"/>
              <a:ext cx="900000" cy="900000"/>
            </a:xfrm>
            <a:prstGeom prst="rect">
              <a:avLst/>
            </a:prstGeom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A48DB085-217B-40BF-A7DA-35333FCFB2D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011398" y="3213165"/>
              <a:ext cx="900000" cy="900000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E1472C8-5179-4E71-9EC5-0B0902A12564}"/>
                </a:ext>
              </a:extLst>
            </p:cNvPr>
            <p:cNvSpPr txBox="1"/>
            <p:nvPr/>
          </p:nvSpPr>
          <p:spPr>
            <a:xfrm rot="16200000">
              <a:off x="1309067" y="3509934"/>
              <a:ext cx="10903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Gametocytes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D4077A8-18A4-496D-9BF5-BEE2F34E6A9D}"/>
                </a:ext>
              </a:extLst>
            </p:cNvPr>
            <p:cNvSpPr txBox="1"/>
            <p:nvPr/>
          </p:nvSpPr>
          <p:spPr>
            <a:xfrm rot="16200000">
              <a:off x="1527076" y="4413338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Zygote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D678C65-1405-425B-85E0-8E105AD26809}"/>
                </a:ext>
              </a:extLst>
            </p:cNvPr>
            <p:cNvSpPr txBox="1"/>
            <p:nvPr/>
          </p:nvSpPr>
          <p:spPr>
            <a:xfrm rot="16200000">
              <a:off x="1454940" y="5386437"/>
              <a:ext cx="7986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Ookinete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D27A34D-BBF8-4395-9ACE-1EDDD92762C0}"/>
                </a:ext>
              </a:extLst>
            </p:cNvPr>
            <p:cNvSpPr txBox="1"/>
            <p:nvPr/>
          </p:nvSpPr>
          <p:spPr>
            <a:xfrm rot="16200000">
              <a:off x="1356356" y="6326202"/>
              <a:ext cx="995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Oocyst-D12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768394A-AF24-487A-BD3D-23BDDA5756F9}"/>
                </a:ext>
              </a:extLst>
            </p:cNvPr>
            <p:cNvSpPr txBox="1"/>
            <p:nvPr/>
          </p:nvSpPr>
          <p:spPr>
            <a:xfrm rot="16200000">
              <a:off x="1356356" y="7285001"/>
              <a:ext cx="995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Oocyst-D2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003AD40-617C-4596-A610-D7678EAB0835}"/>
                </a:ext>
              </a:extLst>
            </p:cNvPr>
            <p:cNvSpPr txBox="1"/>
            <p:nvPr/>
          </p:nvSpPr>
          <p:spPr>
            <a:xfrm rot="16200000">
              <a:off x="1395629" y="8187170"/>
              <a:ext cx="917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Sporozoit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F8964B1-92B8-4A63-9D02-291E41A15792}"/>
                </a:ext>
              </a:extLst>
            </p:cNvPr>
            <p:cNvSpPr txBox="1"/>
            <p:nvPr/>
          </p:nvSpPr>
          <p:spPr>
            <a:xfrm>
              <a:off x="2191097" y="117476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DIC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122FBD1-BD76-4BD7-940B-339CFE53B70F}"/>
                </a:ext>
              </a:extLst>
            </p:cNvPr>
            <p:cNvSpPr txBox="1"/>
            <p:nvPr/>
          </p:nvSpPr>
          <p:spPr>
            <a:xfrm>
              <a:off x="3012452" y="117476"/>
              <a:ext cx="747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0000C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7173D04-879C-4039-BB6A-BD81602806CE}"/>
                </a:ext>
              </a:extLst>
            </p:cNvPr>
            <p:cNvSpPr txBox="1"/>
            <p:nvPr/>
          </p:nvSpPr>
          <p:spPr>
            <a:xfrm>
              <a:off x="3726351" y="117476"/>
              <a:ext cx="12682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00BB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nesin-8B-GFP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1BDB401-C718-4B89-B061-CA2F8392A35A}"/>
                </a:ext>
              </a:extLst>
            </p:cNvPr>
            <p:cNvSpPr txBox="1"/>
            <p:nvPr/>
          </p:nvSpPr>
          <p:spPr>
            <a:xfrm>
              <a:off x="5059814" y="11747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.1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FCBF65D-D28C-4270-B094-6CDF34F7B53C}"/>
                </a:ext>
              </a:extLst>
            </p:cNvPr>
            <p:cNvSpPr txBox="1"/>
            <p:nvPr/>
          </p:nvSpPr>
          <p:spPr>
            <a:xfrm>
              <a:off x="6015104" y="117476"/>
              <a:ext cx="6190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A8BA8B7-0839-4976-A3CB-494A11170CB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2964661" y="3213165"/>
              <a:ext cx="900000" cy="900000"/>
            </a:xfrm>
            <a:prstGeom prst="rect">
              <a:avLst/>
            </a:prstGeom>
          </p:spPr>
        </p:pic>
        <p:pic>
          <p:nvPicPr>
            <p:cNvPr id="1030" name="Picture 6" descr="Image result for female symbol black background">
              <a:extLst>
                <a:ext uri="{FF2B5EF4-FFF2-40B4-BE49-F238E27FC236}">
                  <a16:creationId xmlns:a16="http://schemas.microsoft.com/office/drawing/2014/main" id="{53148C12-4AAF-4D70-B41C-BBDAA550EC8E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2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9276" b="49792"/>
            <a:stretch/>
          </p:blipFill>
          <p:spPr bwMode="auto">
            <a:xfrm>
              <a:off x="6418648" y="3720030"/>
              <a:ext cx="216000" cy="21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6" descr="Image result for female symbol black background">
              <a:extLst>
                <a:ext uri="{FF2B5EF4-FFF2-40B4-BE49-F238E27FC236}">
                  <a16:creationId xmlns:a16="http://schemas.microsoft.com/office/drawing/2014/main" id="{4B2138DC-31AF-499F-9F89-358618000398}"/>
                </a:ext>
              </a:extLst>
            </p:cNvPr>
            <p:cNvPicPr preferRelativeResize="0">
              <a:picLocks noChangeArrowheads="1"/>
            </p:cNvPicPr>
            <p:nvPr/>
          </p:nvPicPr>
          <p:blipFill rotWithShape="1">
            <a:blip r:embed="rId2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34" b="49792"/>
            <a:stretch/>
          </p:blipFill>
          <p:spPr bwMode="auto">
            <a:xfrm>
              <a:off x="5907104" y="3264869"/>
              <a:ext cx="216000" cy="216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5AD091D-538A-40AC-945E-871408BBA4B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64661" y="7903636"/>
              <a:ext cx="900000" cy="9000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B8F986C-2020-4B38-9707-B3AB8BEC51B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923321" y="7903634"/>
              <a:ext cx="900000" cy="9000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2F5014F-C7EA-48AA-8C4C-9BEA593DB01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2">
              <a:lum bright="14000"/>
            </a:blip>
            <a:stretch>
              <a:fillRect/>
            </a:stretch>
          </p:blipFill>
          <p:spPr>
            <a:xfrm rot="16200000">
              <a:off x="2011399" y="5089353"/>
              <a:ext cx="900000" cy="900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95F33EC-3614-4084-B0B7-3D5642C605F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/>
            <a:stretch>
              <a:fillRect/>
            </a:stretch>
          </p:blipFill>
          <p:spPr>
            <a:xfrm rot="16200000">
              <a:off x="2964661" y="5089353"/>
              <a:ext cx="900000" cy="9000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2F8499D-C949-41CE-B453-6F3D011C672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4"/>
            <a:stretch>
              <a:fillRect/>
            </a:stretch>
          </p:blipFill>
          <p:spPr>
            <a:xfrm rot="16200000">
              <a:off x="3923321" y="5089353"/>
              <a:ext cx="900000" cy="9000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58188A3-4D92-47F6-A413-7112080AB30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5"/>
            <a:stretch>
              <a:fillRect/>
            </a:stretch>
          </p:blipFill>
          <p:spPr>
            <a:xfrm rot="16200000">
              <a:off x="4862570" y="5089353"/>
              <a:ext cx="900000" cy="9000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0BC186BA-7CF4-4650-8359-3113C2989FC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2967361" y="398883"/>
              <a:ext cx="900000" cy="90000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17CB3B23-8053-4174-9B46-0D569F07664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>
              <a:lum bright="16000"/>
            </a:blip>
            <a:stretch>
              <a:fillRect/>
            </a:stretch>
          </p:blipFill>
          <p:spPr>
            <a:xfrm>
              <a:off x="2011398" y="398883"/>
              <a:ext cx="900000" cy="90000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48612B4B-273D-4D22-9F39-82307778F3D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4862570" y="398883"/>
              <a:ext cx="900000" cy="900000"/>
            </a:xfrm>
            <a:prstGeom prst="rect">
              <a:avLst/>
            </a:prstGeom>
          </p:spPr>
        </p:pic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E362DC41-834C-45D3-91A1-88877D5C33C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3923321" y="398883"/>
              <a:ext cx="900000" cy="90000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9C0C2C8-ACD5-498E-ADB8-5ACE2F334CC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0">
              <a:lum bright="12000"/>
            </a:blip>
            <a:stretch>
              <a:fillRect/>
            </a:stretch>
          </p:blipFill>
          <p:spPr>
            <a:xfrm>
              <a:off x="2011398" y="1336977"/>
              <a:ext cx="900000" cy="90000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7A19C860-5D29-4E6C-B469-C00850A9EBE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2964661" y="1336977"/>
              <a:ext cx="900000" cy="900000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1D470322-C37E-460C-8C10-69ABF93D4DB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3923321" y="1336977"/>
              <a:ext cx="900000" cy="900000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E20A3B86-1510-4036-942E-12814E80020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4862570" y="1336977"/>
              <a:ext cx="900000" cy="900000"/>
            </a:xfrm>
            <a:prstGeom prst="rect">
              <a:avLst/>
            </a:prstGeom>
          </p:spPr>
        </p:pic>
        <p:pic>
          <p:nvPicPr>
            <p:cNvPr id="1039" name="Picture 1038">
              <a:extLst>
                <a:ext uri="{FF2B5EF4-FFF2-40B4-BE49-F238E27FC236}">
                  <a16:creationId xmlns:a16="http://schemas.microsoft.com/office/drawing/2014/main" id="{BFEECDC6-E533-46B3-ABEF-653BFCF8E60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4">
              <a:lum bright="18000" contrast="38000"/>
            </a:blip>
            <a:stretch>
              <a:fillRect/>
            </a:stretch>
          </p:blipFill>
          <p:spPr>
            <a:xfrm>
              <a:off x="2011398" y="4151259"/>
              <a:ext cx="900000" cy="900000"/>
            </a:xfrm>
            <a:prstGeom prst="rect">
              <a:avLst/>
            </a:prstGeom>
          </p:spPr>
        </p:pic>
        <p:pic>
          <p:nvPicPr>
            <p:cNvPr id="1040" name="Picture 1039">
              <a:extLst>
                <a:ext uri="{FF2B5EF4-FFF2-40B4-BE49-F238E27FC236}">
                  <a16:creationId xmlns:a16="http://schemas.microsoft.com/office/drawing/2014/main" id="{89A904A4-B921-4B02-9143-430D66E91EA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5"/>
            <a:stretch>
              <a:fillRect/>
            </a:stretch>
          </p:blipFill>
          <p:spPr>
            <a:xfrm>
              <a:off x="2964661" y="4151259"/>
              <a:ext cx="900000" cy="900000"/>
            </a:xfrm>
            <a:prstGeom prst="rect">
              <a:avLst/>
            </a:prstGeom>
          </p:spPr>
        </p:pic>
        <p:pic>
          <p:nvPicPr>
            <p:cNvPr id="1041" name="Picture 1040">
              <a:extLst>
                <a:ext uri="{FF2B5EF4-FFF2-40B4-BE49-F238E27FC236}">
                  <a16:creationId xmlns:a16="http://schemas.microsoft.com/office/drawing/2014/main" id="{B368C160-8177-4BC1-9C04-D554F0520E2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3923321" y="4151259"/>
              <a:ext cx="900000" cy="900000"/>
            </a:xfrm>
            <a:prstGeom prst="rect">
              <a:avLst/>
            </a:prstGeom>
          </p:spPr>
        </p:pic>
        <p:pic>
          <p:nvPicPr>
            <p:cNvPr id="1042" name="Picture 1041">
              <a:extLst>
                <a:ext uri="{FF2B5EF4-FFF2-40B4-BE49-F238E27FC236}">
                  <a16:creationId xmlns:a16="http://schemas.microsoft.com/office/drawing/2014/main" id="{CE2FF7B8-1649-4235-9887-ED12DF89F6E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6"/>
            <a:stretch>
              <a:fillRect/>
            </a:stretch>
          </p:blipFill>
          <p:spPr>
            <a:xfrm>
              <a:off x="4862570" y="4151259"/>
              <a:ext cx="900000" cy="900000"/>
            </a:xfrm>
            <a:prstGeom prst="rect">
              <a:avLst/>
            </a:prstGeom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63FD5DCD-E3AE-4C1D-9C8D-16ED0133CE5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7"/>
            <a:stretch>
              <a:fillRect/>
            </a:stretch>
          </p:blipFill>
          <p:spPr>
            <a:xfrm>
              <a:off x="4862570" y="7903634"/>
              <a:ext cx="900000" cy="900000"/>
            </a:xfrm>
            <a:prstGeom prst="rect">
              <a:avLst/>
            </a:prstGeom>
          </p:spPr>
        </p:pic>
        <p:pic>
          <p:nvPicPr>
            <p:cNvPr id="73" name="Picture 2">
              <a:extLst>
                <a:ext uri="{FF2B5EF4-FFF2-40B4-BE49-F238E27FC236}">
                  <a16:creationId xmlns:a16="http://schemas.microsoft.com/office/drawing/2014/main" id="{E7DCC6BE-950C-4D49-AEC3-EC39A9EDB6F1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8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brightnessContrast bright="16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1398" y="2275071"/>
              <a:ext cx="900000" cy="9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5" name="Picture 3">
              <a:extLst>
                <a:ext uri="{FF2B5EF4-FFF2-40B4-BE49-F238E27FC236}">
                  <a16:creationId xmlns:a16="http://schemas.microsoft.com/office/drawing/2014/main" id="{751420AF-6902-4A15-AF73-0F5D7C13256A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964661" y="2275071"/>
              <a:ext cx="900000" cy="9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6" name="Picture 4">
              <a:extLst>
                <a:ext uri="{FF2B5EF4-FFF2-40B4-BE49-F238E27FC236}">
                  <a16:creationId xmlns:a16="http://schemas.microsoft.com/office/drawing/2014/main" id="{6C2D0991-3135-439E-99EF-D4A395A256AD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40"/>
            <a:srcRect/>
            <a:stretch>
              <a:fillRect/>
            </a:stretch>
          </p:blipFill>
          <p:spPr bwMode="auto">
            <a:xfrm>
              <a:off x="3923321" y="2275071"/>
              <a:ext cx="900000" cy="9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7" name="Picture 5">
              <a:extLst>
                <a:ext uri="{FF2B5EF4-FFF2-40B4-BE49-F238E27FC236}">
                  <a16:creationId xmlns:a16="http://schemas.microsoft.com/office/drawing/2014/main" id="{ABF54C57-DEA3-4D15-AC20-0D07E656BFFA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40"/>
            <a:srcRect/>
            <a:stretch>
              <a:fillRect/>
            </a:stretch>
          </p:blipFill>
          <p:spPr bwMode="auto">
            <a:xfrm>
              <a:off x="4862570" y="2275071"/>
              <a:ext cx="900000" cy="9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8" name="TextBox 7"/>
          <p:cNvSpPr txBox="1"/>
          <p:nvPr/>
        </p:nvSpPr>
        <p:spPr>
          <a:xfrm>
            <a:off x="133466" y="917125"/>
            <a:ext cx="15616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 S3-data source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5831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</TotalTime>
  <Words>17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zeeshan</dc:creator>
  <cp:lastModifiedBy>Mohammad Zeeshan</cp:lastModifiedBy>
  <cp:revision>26</cp:revision>
  <dcterms:created xsi:type="dcterms:W3CDTF">2019-07-28T21:19:35Z</dcterms:created>
  <dcterms:modified xsi:type="dcterms:W3CDTF">2019-08-05T09:17:39Z</dcterms:modified>
</cp:coreProperties>
</file>